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05" d="100"/>
          <a:sy n="105" d="100"/>
        </p:scale>
        <p:origin x="79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8F0C7B1-04AB-A3DE-3373-9A42C80E09F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B438C5EE-FFC0-DDFA-C94D-A29D19CC075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1A69AF0-4D0B-3EA9-FBF8-10EBDB8D49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B68C2-1067-6C43-BA1C-35E12CA48A31}" type="datetimeFigureOut">
              <a:rPr kumimoji="1" lang="ja-JP" altLang="en-US" smtClean="0"/>
              <a:t>2025/9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3D19B6F-BAA4-7F68-FBB7-2E2E759358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EF64280-3A1B-523B-F915-3F50835929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B5E86-DC60-4841-8DC1-E314F26C2F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41262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21B6F88-8DEF-E907-6129-B4A2750D8A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61487B5-31CA-AFE4-1176-7B43E1395A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E932E90-8369-3034-6167-36EA85DBB2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B68C2-1067-6C43-BA1C-35E12CA48A31}" type="datetimeFigureOut">
              <a:rPr kumimoji="1" lang="ja-JP" altLang="en-US" smtClean="0"/>
              <a:t>2025/9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C0F9666-0F2B-241E-BFC1-732CA9F88C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7BE0717-F725-E700-0005-E5CFC6C0F4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B5E86-DC60-4841-8DC1-E314F26C2F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85070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F82BACB0-16A6-ACE2-491F-7A2F8C7C315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A28ABCB-F924-A7DD-2652-4AA9B671E48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82B408F-ECF3-D214-F9C1-112E156B0C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B68C2-1067-6C43-BA1C-35E12CA48A31}" type="datetimeFigureOut">
              <a:rPr kumimoji="1" lang="ja-JP" altLang="en-US" smtClean="0"/>
              <a:t>2025/9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5C91B61-8637-7F1E-EEFE-FF6BDB1C8B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3041359-966E-7263-8424-23DC1CF279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B5E86-DC60-4841-8DC1-E314F26C2F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47713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7A3732A-D7D7-3B85-464A-70F4FFE490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495BEF0-4D03-EA50-9830-A1195B0908F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ECFD15B-5067-4341-8376-B25027C94B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B68C2-1067-6C43-BA1C-35E12CA48A31}" type="datetimeFigureOut">
              <a:rPr kumimoji="1" lang="ja-JP" altLang="en-US" smtClean="0"/>
              <a:t>2025/9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EA3FC4B-10F5-CB81-EE9E-0255914F6C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41CD276-FBF6-ED37-0F85-9762F7C90A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B5E86-DC60-4841-8DC1-E314F26C2F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12407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5D2A1C4-FC86-7F89-DFE9-00579BC76B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C0E56BA-C2D1-FEE0-3C30-6D105CE1FB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A5C4637-AEC3-41BB-AB4D-E1A5C089C6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B68C2-1067-6C43-BA1C-35E12CA48A31}" type="datetimeFigureOut">
              <a:rPr kumimoji="1" lang="ja-JP" altLang="en-US" smtClean="0"/>
              <a:t>2025/9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BFEB304-D4B5-9D45-B1DE-AC60F92519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60851B4-9C11-B7D8-4400-5EEF15FC1B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B5E86-DC60-4841-8DC1-E314F26C2F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29767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A071B12-DFCA-1AFA-713B-75EF001E1A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31F2F00-8BDD-0883-4C16-A49F7158AB8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FC42747-3678-D7CA-033C-54275C1D0C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C7BAC7B-9439-ABF0-B949-BB930083C7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B68C2-1067-6C43-BA1C-35E12CA48A31}" type="datetimeFigureOut">
              <a:rPr kumimoji="1" lang="ja-JP" altLang="en-US" smtClean="0"/>
              <a:t>2025/9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4803A7A-2DC6-A850-4ABF-BD4714ED06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F91F67A-5DAD-D7DC-53D0-DA921317A1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B5E86-DC60-4841-8DC1-E314F26C2F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46047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428B214-18EA-F142-3977-AD4CC27348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F2723BD-08F0-C218-9EE5-3644A8B4B0D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F5AB3CF-DDC8-9A81-50DA-1D6D252809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F1851E6-B192-33D5-2867-5C918A20878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52EBE2E-AE5E-3DD4-7FEF-0BF89070D18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F45AD4D-FB03-CA32-20A0-90FE40AD65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B68C2-1067-6C43-BA1C-35E12CA48A31}" type="datetimeFigureOut">
              <a:rPr kumimoji="1" lang="ja-JP" altLang="en-US" smtClean="0"/>
              <a:t>2025/9/24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D3B02A9-18B5-264D-79E5-CF9683C1EA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A8934C3-133A-2584-8B39-2A7D1DC09C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B5E86-DC60-4841-8DC1-E314F26C2F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78539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C5DA48F-1A29-7897-BE05-800737F186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02D700D0-DA79-6FFC-7A37-ECF5244E89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B68C2-1067-6C43-BA1C-35E12CA48A31}" type="datetimeFigureOut">
              <a:rPr kumimoji="1" lang="ja-JP" altLang="en-US" smtClean="0"/>
              <a:t>2025/9/24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C190737D-0F1E-0559-661D-92A9852EF6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44B086DA-A4B1-3E67-F7F8-C44786D82D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B5E86-DC60-4841-8DC1-E314F26C2F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1444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C6CF97B-BD1E-6A4F-8E8D-B52095CE30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B68C2-1067-6C43-BA1C-35E12CA48A31}" type="datetimeFigureOut">
              <a:rPr kumimoji="1" lang="ja-JP" altLang="en-US" smtClean="0"/>
              <a:t>2025/9/24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FCC2983-2E14-8F47-C6FE-19B9812D70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1838E7EC-3A9C-4F33-570C-FA63BE52F7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B5E86-DC60-4841-8DC1-E314F26C2F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33217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9DCBA34-FEB9-C240-DF06-B21064C28E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BD75EB9-F137-8998-B417-07BEFEB3BFD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A42DFF92-C239-B0AB-41F8-78516D8BA0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378C40D-45DD-5FF6-B70A-6337D2DC75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B68C2-1067-6C43-BA1C-35E12CA48A31}" type="datetimeFigureOut">
              <a:rPr kumimoji="1" lang="ja-JP" altLang="en-US" smtClean="0"/>
              <a:t>2025/9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E1300A0-E704-802B-84E7-8ECDEBDD8F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1C4AE07-F066-354F-F3C9-A64F2FAB63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B5E86-DC60-4841-8DC1-E314F26C2F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90416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6EFD96E-0CC7-997C-03F9-B251C24B7D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46DC1153-0216-574D-F9B6-3729BBCC462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13DB144-75A4-64D9-550F-1CCEC8F084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272D6D9-AC4D-A4CE-20D6-BF9BA16943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5B68C2-1067-6C43-BA1C-35E12CA48A31}" type="datetimeFigureOut">
              <a:rPr kumimoji="1" lang="ja-JP" altLang="en-US" smtClean="0"/>
              <a:t>2025/9/24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3285582-1D14-5511-980D-720DC786D1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4690D56-98CE-33D9-DC55-8F32920A63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EB5E86-DC60-4841-8DC1-E314F26C2F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65808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D8E57A0-BDEA-3CC2-D31C-60D1F36594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AB49B2C-EA8D-EEB7-9118-C6B21426BA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DCBDFAC-7630-B8A5-133B-1C071130811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5B68C2-1067-6C43-BA1C-35E12CA48A31}" type="datetimeFigureOut">
              <a:rPr kumimoji="1" lang="ja-JP" altLang="en-US" smtClean="0"/>
              <a:t>2025/9/24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5D86201-729B-C2D8-E217-BEBE6331F8B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BA0A876-D182-C08B-7F96-459218CED2C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EB5E86-DC60-4841-8DC1-E314F26C2F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99478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82E0CBE-1F21-47EE-C514-13BF7262E703}"/>
              </a:ext>
            </a:extLst>
          </p:cNvPr>
          <p:cNvSpPr txBox="1"/>
          <p:nvPr/>
        </p:nvSpPr>
        <p:spPr>
          <a:xfrm>
            <a:off x="3784130" y="1462543"/>
            <a:ext cx="4046301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ja-JP" dirty="0"/>
              <a:t>Anatomical &amp; </a:t>
            </a:r>
            <a:r>
              <a:rPr kumimoji="1" lang="en-US" altLang="ja-JP" dirty="0"/>
              <a:t>Pathological analyses </a:t>
            </a:r>
          </a:p>
          <a:p>
            <a:r>
              <a:rPr lang="en-US" altLang="ja-JP" dirty="0"/>
              <a:t>of the case </a:t>
            </a:r>
            <a:r>
              <a:rPr kumimoji="1" lang="en-US" altLang="ja-JP" dirty="0"/>
              <a:t>(Fig. 1, 2)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1F69D7F-A2B3-1137-05F0-D3CC0891CDB0}"/>
              </a:ext>
            </a:extLst>
          </p:cNvPr>
          <p:cNvSpPr txBox="1"/>
          <p:nvPr/>
        </p:nvSpPr>
        <p:spPr>
          <a:xfrm>
            <a:off x="3994295" y="2385873"/>
            <a:ext cx="3669594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ja-JP" dirty="0"/>
              <a:t>Genetic </a:t>
            </a:r>
            <a:r>
              <a:rPr kumimoji="1" lang="en-US" altLang="ja-JP" dirty="0"/>
              <a:t>analysis</a:t>
            </a:r>
          </a:p>
          <a:p>
            <a:r>
              <a:rPr lang="en-US" altLang="ja-JP" dirty="0"/>
              <a:t>Variant identification (Fig. 3A, B)</a:t>
            </a:r>
            <a:endParaRPr kumimoji="1" lang="en-US" altLang="ja-JP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A42BD32-6EB6-85F7-F30A-26FDC3D7E815}"/>
              </a:ext>
            </a:extLst>
          </p:cNvPr>
          <p:cNvSpPr txBox="1"/>
          <p:nvPr/>
        </p:nvSpPr>
        <p:spPr>
          <a:xfrm>
            <a:off x="1283730" y="3238494"/>
            <a:ext cx="2339102" cy="12003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ja-JP" b="1" i="1" dirty="0"/>
              <a:t>In silico </a:t>
            </a:r>
            <a:r>
              <a:rPr kumimoji="1" lang="en-US" altLang="ja-JP" b="1" dirty="0"/>
              <a:t>analyses</a:t>
            </a:r>
          </a:p>
          <a:p>
            <a:r>
              <a:rPr lang="en-US" altLang="ja-JP" dirty="0"/>
              <a:t>* Intolerance test</a:t>
            </a:r>
          </a:p>
          <a:p>
            <a:r>
              <a:rPr kumimoji="1" lang="en-US" altLang="ja-JP" dirty="0"/>
              <a:t>* Structural analysis</a:t>
            </a:r>
          </a:p>
          <a:p>
            <a:r>
              <a:rPr lang="en-US" altLang="ja-JP" dirty="0"/>
              <a:t>(Fig. 3C, D)</a:t>
            </a:r>
            <a:endParaRPr kumimoji="1" lang="en-US" altLang="ja-JP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2AB6D14-274C-4BC0-6EA6-CCF562A852C5}"/>
              </a:ext>
            </a:extLst>
          </p:cNvPr>
          <p:cNvSpPr txBox="1"/>
          <p:nvPr/>
        </p:nvSpPr>
        <p:spPr>
          <a:xfrm>
            <a:off x="3883014" y="3426390"/>
            <a:ext cx="3711272" cy="175432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ja-JP" b="1" i="1" dirty="0"/>
              <a:t>In vitro </a:t>
            </a:r>
            <a:r>
              <a:rPr kumimoji="1" lang="en-US" altLang="ja-JP" b="1" dirty="0"/>
              <a:t>analyses</a:t>
            </a:r>
          </a:p>
          <a:p>
            <a:r>
              <a:rPr lang="en-US" altLang="ja-JP" dirty="0"/>
              <a:t>* GTP/GDP binding (Fig. 4A, B)</a:t>
            </a:r>
          </a:p>
          <a:p>
            <a:r>
              <a:rPr lang="en-US" altLang="ja-JP" dirty="0"/>
              <a:t>* GTP hydrolysis (Fig. 4C)</a:t>
            </a:r>
          </a:p>
          <a:p>
            <a:r>
              <a:rPr lang="en-US" altLang="ja-JP" dirty="0"/>
              <a:t>* Effector binding (Fig. 4A-D)</a:t>
            </a:r>
          </a:p>
          <a:p>
            <a:r>
              <a:rPr kumimoji="1" lang="en-US" altLang="ja-JP" dirty="0"/>
              <a:t>* Transcription </a:t>
            </a:r>
            <a:r>
              <a:rPr lang="en-US" altLang="ja-JP" dirty="0"/>
              <a:t>(Fig. 4E-G)</a:t>
            </a:r>
            <a:endParaRPr kumimoji="1" lang="en-US" altLang="ja-JP" dirty="0"/>
          </a:p>
          <a:p>
            <a:r>
              <a:rPr kumimoji="1" lang="en-US" altLang="ja-JP" dirty="0"/>
              <a:t>* Culture cell morphology (Fig. 5)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B3CACB6-9116-B3AD-A37C-AF984C81E48E}"/>
              </a:ext>
            </a:extLst>
          </p:cNvPr>
          <p:cNvSpPr txBox="1"/>
          <p:nvPr/>
        </p:nvSpPr>
        <p:spPr>
          <a:xfrm>
            <a:off x="7926835" y="3317488"/>
            <a:ext cx="3042821" cy="12003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altLang="ja-JP" b="1" i="1" dirty="0"/>
              <a:t>In vivo </a:t>
            </a:r>
            <a:r>
              <a:rPr kumimoji="1" lang="en-US" altLang="ja-JP" b="1" dirty="0"/>
              <a:t>analyses</a:t>
            </a:r>
          </a:p>
          <a:p>
            <a:r>
              <a:rPr lang="en-US" altLang="ja-JP" dirty="0"/>
              <a:t>* Neuron migration (Fig. 7)</a:t>
            </a:r>
          </a:p>
          <a:p>
            <a:r>
              <a:rPr lang="en-US" altLang="ja-JP" dirty="0"/>
              <a:t>* Axon elongation (Fig. 8)</a:t>
            </a:r>
          </a:p>
          <a:p>
            <a:r>
              <a:rPr lang="en-US" altLang="ja-JP" dirty="0"/>
              <a:t>* </a:t>
            </a:r>
            <a:r>
              <a:rPr lang="en-US" altLang="ja-JP" dirty="0" err="1"/>
              <a:t>Dendritogenesis</a:t>
            </a:r>
            <a:r>
              <a:rPr lang="en-US" altLang="ja-JP" dirty="0"/>
              <a:t> (Fig. 9)</a:t>
            </a:r>
          </a:p>
        </p:txBody>
      </p:sp>
      <p:sp>
        <p:nvSpPr>
          <p:cNvPr id="9" name="下矢印 8">
            <a:extLst>
              <a:ext uri="{FF2B5EF4-FFF2-40B4-BE49-F238E27FC236}">
                <a16:creationId xmlns:a16="http://schemas.microsoft.com/office/drawing/2014/main" id="{E3CB41D5-8DB9-F111-E0C9-355281547562}"/>
              </a:ext>
            </a:extLst>
          </p:cNvPr>
          <p:cNvSpPr/>
          <p:nvPr/>
        </p:nvSpPr>
        <p:spPr>
          <a:xfrm>
            <a:off x="5450720" y="2188816"/>
            <a:ext cx="378372" cy="173365"/>
          </a:xfrm>
          <a:prstGeom prst="down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下矢印 9">
            <a:extLst>
              <a:ext uri="{FF2B5EF4-FFF2-40B4-BE49-F238E27FC236}">
                <a16:creationId xmlns:a16="http://schemas.microsoft.com/office/drawing/2014/main" id="{1082DB79-CACE-C478-5A0B-653968C0AF98}"/>
              </a:ext>
            </a:extLst>
          </p:cNvPr>
          <p:cNvSpPr/>
          <p:nvPr/>
        </p:nvSpPr>
        <p:spPr>
          <a:xfrm>
            <a:off x="5485548" y="3151812"/>
            <a:ext cx="378372" cy="173365"/>
          </a:xfrm>
          <a:prstGeom prst="down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下矢印 10">
            <a:extLst>
              <a:ext uri="{FF2B5EF4-FFF2-40B4-BE49-F238E27FC236}">
                <a16:creationId xmlns:a16="http://schemas.microsoft.com/office/drawing/2014/main" id="{642B1991-23B7-D261-F034-16697F221717}"/>
              </a:ext>
            </a:extLst>
          </p:cNvPr>
          <p:cNvSpPr/>
          <p:nvPr/>
        </p:nvSpPr>
        <p:spPr>
          <a:xfrm rot="3490798">
            <a:off x="3594944" y="2985035"/>
            <a:ext cx="378372" cy="296762"/>
          </a:xfrm>
          <a:prstGeom prst="down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下矢印 11">
            <a:extLst>
              <a:ext uri="{FF2B5EF4-FFF2-40B4-BE49-F238E27FC236}">
                <a16:creationId xmlns:a16="http://schemas.microsoft.com/office/drawing/2014/main" id="{3A05B605-451B-C51A-64F5-99FEB4DDC7D7}"/>
              </a:ext>
            </a:extLst>
          </p:cNvPr>
          <p:cNvSpPr/>
          <p:nvPr/>
        </p:nvSpPr>
        <p:spPr>
          <a:xfrm rot="18701627">
            <a:off x="7641735" y="3003382"/>
            <a:ext cx="378372" cy="296762"/>
          </a:xfrm>
          <a:prstGeom prst="downArrow">
            <a:avLst/>
          </a:prstGeom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AFDD9D9E-1ACF-CA33-CB6E-729F791EFDF8}"/>
              </a:ext>
            </a:extLst>
          </p:cNvPr>
          <p:cNvSpPr txBox="1"/>
          <p:nvPr/>
        </p:nvSpPr>
        <p:spPr>
          <a:xfrm>
            <a:off x="1194212" y="5843752"/>
            <a:ext cx="978184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/>
              <a:t>Supplementary Figure </a:t>
            </a:r>
            <a:r>
              <a:rPr kumimoji="1" lang="en-US" altLang="ja-JP" sz="2000" b="1" dirty="0"/>
              <a:t>S1. </a:t>
            </a:r>
            <a:r>
              <a:rPr lang="en-US" altLang="ja-JP" sz="2000" b="1" dirty="0"/>
              <a:t>Schematic representation of experimental design </a:t>
            </a:r>
            <a:endParaRPr kumimoji="1" lang="ja-JP" alt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33091902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123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浩一 永田</dc:creator>
  <cp:lastModifiedBy>MDPI</cp:lastModifiedBy>
  <cp:revision>4</cp:revision>
  <dcterms:created xsi:type="dcterms:W3CDTF">2025-07-28T01:09:45Z</dcterms:created>
  <dcterms:modified xsi:type="dcterms:W3CDTF">2025-09-24T14:28:01Z</dcterms:modified>
</cp:coreProperties>
</file>